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6" r:id="rId2"/>
    <p:sldId id="280" r:id="rId3"/>
    <p:sldId id="282" r:id="rId4"/>
    <p:sldId id="281" r:id="rId5"/>
    <p:sldId id="287" r:id="rId6"/>
    <p:sldId id="266" r:id="rId7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0CEC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6767D70-36AC-4FDC-9825-32E048802BB6}" v="2" dt="2022-11-18T22:09:10.74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26" autoAdjust="0"/>
    <p:restoredTop sz="94660"/>
  </p:normalViewPr>
  <p:slideViewPr>
    <p:cSldViewPr snapToGrid="0">
      <p:cViewPr>
        <p:scale>
          <a:sx n="125" d="100"/>
          <a:sy n="125" d="100"/>
        </p:scale>
        <p:origin x="2088" y="-4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ianjing Hu" userId="b2f867aa-f6bf-44a2-815c-290ffe0eebff" providerId="ADAL" clId="{A6767D70-36AC-4FDC-9825-32E048802BB6}"/>
    <pc:docChg chg="modSld">
      <pc:chgData name="Tianjing Hu" userId="b2f867aa-f6bf-44a2-815c-290ffe0eebff" providerId="ADAL" clId="{A6767D70-36AC-4FDC-9825-32E048802BB6}" dt="2022-11-18T22:09:10.747" v="2" actId="164"/>
      <pc:docMkLst>
        <pc:docMk/>
      </pc:docMkLst>
      <pc:sldChg chg="addSp modSp mod">
        <pc:chgData name="Tianjing Hu" userId="b2f867aa-f6bf-44a2-815c-290ffe0eebff" providerId="ADAL" clId="{A6767D70-36AC-4FDC-9825-32E048802BB6}" dt="2022-11-18T22:09:10.747" v="2" actId="164"/>
        <pc:sldMkLst>
          <pc:docMk/>
          <pc:sldMk cId="297150947" sldId="287"/>
        </pc:sldMkLst>
        <pc:grpChg chg="add mod">
          <ac:chgData name="Tianjing Hu" userId="b2f867aa-f6bf-44a2-815c-290ffe0eebff" providerId="ADAL" clId="{A6767D70-36AC-4FDC-9825-32E048802BB6}" dt="2022-11-18T22:09:10.747" v="2" actId="164"/>
          <ac:grpSpMkLst>
            <pc:docMk/>
            <pc:sldMk cId="297150947" sldId="287"/>
            <ac:grpSpMk id="4" creationId="{58ED7440-DAD8-9C07-B59D-F1B066DBDC82}"/>
          </ac:grpSpMkLst>
        </pc:grpChg>
        <pc:graphicFrameChg chg="mod">
          <ac:chgData name="Tianjing Hu" userId="b2f867aa-f6bf-44a2-815c-290ffe0eebff" providerId="ADAL" clId="{A6767D70-36AC-4FDC-9825-32E048802BB6}" dt="2022-11-18T22:09:10.747" v="2" actId="164"/>
          <ac:graphicFrameMkLst>
            <pc:docMk/>
            <pc:sldMk cId="297150947" sldId="287"/>
            <ac:graphicFrameMk id="2" creationId="{5D716A0B-E8F6-4007-93DC-2E2BBD782E4F}"/>
          </ac:graphicFrameMkLst>
        </pc:graphicFrameChg>
        <pc:graphicFrameChg chg="mod">
          <ac:chgData name="Tianjing Hu" userId="b2f867aa-f6bf-44a2-815c-290ffe0eebff" providerId="ADAL" clId="{A6767D70-36AC-4FDC-9825-32E048802BB6}" dt="2022-11-18T22:09:10.747" v="2" actId="164"/>
          <ac:graphicFrameMkLst>
            <pc:docMk/>
            <pc:sldMk cId="297150947" sldId="287"/>
            <ac:graphicFrameMk id="3" creationId="{4FC318B6-89A7-48C8-834D-1B8F962F6B8F}"/>
          </ac:graphicFrameMkLst>
        </pc:graphicFrameChg>
        <pc:graphicFrameChg chg="mod">
          <ac:chgData name="Tianjing Hu" userId="b2f867aa-f6bf-44a2-815c-290ffe0eebff" providerId="ADAL" clId="{A6767D70-36AC-4FDC-9825-32E048802BB6}" dt="2022-11-18T22:09:10.747" v="2" actId="164"/>
          <ac:graphicFrameMkLst>
            <pc:docMk/>
            <pc:sldMk cId="297150947" sldId="287"/>
            <ac:graphicFrameMk id="5" creationId="{8AEE2A52-1949-463D-A732-B1405AD009C2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../embeddings/oleObject1.bin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../embeddings/oleObject2.bin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../embeddings/oleObject3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S5</a:t>
            </a:r>
          </a:p>
        </c:rich>
      </c:tx>
      <c:layout>
        <c:manualLayout>
          <c:xMode val="edge"/>
          <c:yMode val="edge"/>
          <c:x val="0.27174016042805738"/>
          <c:y val="0.1367735782262711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6079195276360995"/>
          <c:y val="0.15975582888626941"/>
          <c:w val="0.63071733364808702"/>
          <c:h val="0.63467354094248885"/>
        </c:manualLayout>
      </c:layout>
      <c:scatterChart>
        <c:scatterStyle val="lineMarker"/>
        <c:varyColors val="0"/>
        <c:ser>
          <c:idx val="0"/>
          <c:order val="0"/>
          <c:tx>
            <c:strRef>
              <c:f>'[User 3-ATCC Contrived Accuracy and Precision Analysis.xlsx]Set 1 Data'!$AA$2:$AA$9</c:f>
              <c:strCache>
                <c:ptCount val="8"/>
                <c:pt idx="0">
                  <c:v>Standar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solidFill>
                <a:sysClr val="windowText" lastClr="00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trendline>
            <c:spPr>
              <a:ln w="19050" cap="rnd">
                <a:solidFill>
                  <a:sysClr val="windowText" lastClr="000000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0.1491890131561093"/>
                  <c:y val="0.22160265656364039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[User 3-ATCC Contrived Accuracy and Precision Analysis.xlsx]Set 1 Data'!$AF$2:$AF$9</c:f>
              <c:numCache>
                <c:formatCode>General</c:formatCode>
                <c:ptCount val="8"/>
                <c:pt idx="0">
                  <c:v>0.6</c:v>
                </c:pt>
                <c:pt idx="1">
                  <c:v>0.48</c:v>
                </c:pt>
                <c:pt idx="2">
                  <c:v>0.36</c:v>
                </c:pt>
                <c:pt idx="3">
                  <c:v>0.24</c:v>
                </c:pt>
                <c:pt idx="4">
                  <c:v>0.12</c:v>
                </c:pt>
                <c:pt idx="5">
                  <c:v>0.06</c:v>
                </c:pt>
                <c:pt idx="6">
                  <c:v>0.03</c:v>
                </c:pt>
                <c:pt idx="7">
                  <c:v>0</c:v>
                </c:pt>
              </c:numCache>
            </c:numRef>
          </c:xVal>
          <c:yVal>
            <c:numRef>
              <c:f>'[User 3-ATCC Contrived Accuracy and Precision Analysis.xlsx]Set 1 Data'!$F$20:$F$27</c:f>
              <c:numCache>
                <c:formatCode>##0</c:formatCode>
                <c:ptCount val="8"/>
                <c:pt idx="0">
                  <c:v>37287</c:v>
                </c:pt>
                <c:pt idx="1">
                  <c:v>33663.5</c:v>
                </c:pt>
                <c:pt idx="2">
                  <c:v>24708.5</c:v>
                </c:pt>
                <c:pt idx="3">
                  <c:v>17422.5</c:v>
                </c:pt>
                <c:pt idx="4">
                  <c:v>10401.5</c:v>
                </c:pt>
                <c:pt idx="5">
                  <c:v>6239.5</c:v>
                </c:pt>
                <c:pt idx="6">
                  <c:v>3280.5</c:v>
                </c:pt>
                <c:pt idx="7">
                  <c:v>4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AAD-46A7-96E3-10DECC240F45}"/>
            </c:ext>
          </c:extLst>
        </c:ser>
        <c:ser>
          <c:idx val="1"/>
          <c:order val="1"/>
          <c:tx>
            <c:strRef>
              <c:f>'[User 3-ATCC Contrived Accuracy and Precision Analysis.xlsx]Set 1 Data'!$AA$10:$AA$17</c:f>
              <c:strCache>
                <c:ptCount val="8"/>
                <c:pt idx="0">
                  <c:v>Rep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ysClr val="windowText" lastClr="00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[User 3-ATCC Contrived Accuracy and Precision Analysis.xlsx]Set 1 Data'!$AF$10:$AF$17</c:f>
              <c:numCache>
                <c:formatCode>General</c:formatCode>
                <c:ptCount val="8"/>
                <c:pt idx="0">
                  <c:v>0.15</c:v>
                </c:pt>
                <c:pt idx="1">
                  <c:v>0.15</c:v>
                </c:pt>
                <c:pt idx="2">
                  <c:v>0.15</c:v>
                </c:pt>
                <c:pt idx="3">
                  <c:v>0.15</c:v>
                </c:pt>
                <c:pt idx="4">
                  <c:v>0.15</c:v>
                </c:pt>
                <c:pt idx="5">
                  <c:v>0.15</c:v>
                </c:pt>
                <c:pt idx="6">
                  <c:v>0.15</c:v>
                </c:pt>
                <c:pt idx="7">
                  <c:v>0.15</c:v>
                </c:pt>
              </c:numCache>
            </c:numRef>
          </c:xVal>
          <c:yVal>
            <c:numRef>
              <c:f>'[User 3-ATCC Contrived Accuracy and Precision Analysis.xlsx]Set 1 Data'!$F$28:$F$35</c:f>
              <c:numCache>
                <c:formatCode>##0</c:formatCode>
                <c:ptCount val="8"/>
                <c:pt idx="0">
                  <c:v>11874.5</c:v>
                </c:pt>
                <c:pt idx="1">
                  <c:v>10575.5</c:v>
                </c:pt>
                <c:pt idx="2">
                  <c:v>9974.5</c:v>
                </c:pt>
                <c:pt idx="3">
                  <c:v>10393.5</c:v>
                </c:pt>
                <c:pt idx="4">
                  <c:v>12346</c:v>
                </c:pt>
                <c:pt idx="5">
                  <c:v>13147</c:v>
                </c:pt>
                <c:pt idx="6">
                  <c:v>12164.5</c:v>
                </c:pt>
                <c:pt idx="7">
                  <c:v>111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AAD-46A7-96E3-10DECC240F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0437903"/>
        <c:axId val="320430415"/>
      </c:scatterChart>
      <c:valAx>
        <c:axId val="32043790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0430415"/>
        <c:crosses val="autoZero"/>
        <c:crossBetween val="midCat"/>
      </c:valAx>
      <c:valAx>
        <c:axId val="3204304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>
                    <a:solidFill>
                      <a:schemeClr val="tx1"/>
                    </a:solidFill>
                  </a:rPr>
                  <a:t>Median-BKGD (RFU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043790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S10A</a:t>
            </a:r>
          </a:p>
        </c:rich>
      </c:tx>
      <c:layout>
        <c:manualLayout>
          <c:xMode val="edge"/>
          <c:yMode val="edge"/>
          <c:x val="0.21694969126713687"/>
          <c:y val="0.1522746573997629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172827513705052"/>
          <c:y val="0.17398816719222754"/>
          <c:w val="0.60883157433576007"/>
          <c:h val="0.65048459629591959"/>
        </c:manualLayout>
      </c:layout>
      <c:scatterChart>
        <c:scatterStyle val="lineMarker"/>
        <c:varyColors val="0"/>
        <c:ser>
          <c:idx val="0"/>
          <c:order val="0"/>
          <c:tx>
            <c:strRef>
              <c:f>'[User 3-ATCC Contrived Accuracy and Precision Analysis.xlsx]Set 2 Data'!$AA$2:$AA$9</c:f>
              <c:strCache>
                <c:ptCount val="8"/>
                <c:pt idx="0">
                  <c:v>Standar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solidFill>
                <a:sysClr val="windowText" lastClr="00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trendline>
            <c:spPr>
              <a:ln w="19050" cap="rnd">
                <a:solidFill>
                  <a:sysClr val="windowText" lastClr="000000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0.20215150537812604"/>
                  <c:y val="0.25993453261209437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[User 3-ATCC Contrived Accuracy and Precision Analysis.xlsx]Set 2 Data'!$AM$2:$AM$9</c:f>
              <c:numCache>
                <c:formatCode>General</c:formatCode>
                <c:ptCount val="8"/>
                <c:pt idx="0">
                  <c:v>0.6</c:v>
                </c:pt>
                <c:pt idx="1">
                  <c:v>0.48</c:v>
                </c:pt>
                <c:pt idx="2">
                  <c:v>0.36</c:v>
                </c:pt>
                <c:pt idx="3">
                  <c:v>0.24</c:v>
                </c:pt>
                <c:pt idx="4">
                  <c:v>0.12</c:v>
                </c:pt>
                <c:pt idx="5">
                  <c:v>0.06</c:v>
                </c:pt>
                <c:pt idx="6">
                  <c:v>0.03</c:v>
                </c:pt>
                <c:pt idx="7">
                  <c:v>0</c:v>
                </c:pt>
              </c:numCache>
            </c:numRef>
          </c:xVal>
          <c:yVal>
            <c:numRef>
              <c:f>'[User 3-ATCC Contrived Accuracy and Precision Analysis.xlsx]Set 2 Data'!$M$20:$M$27</c:f>
              <c:numCache>
                <c:formatCode>##0</c:formatCode>
                <c:ptCount val="8"/>
                <c:pt idx="0">
                  <c:v>34010.5</c:v>
                </c:pt>
                <c:pt idx="1">
                  <c:v>25831.5</c:v>
                </c:pt>
                <c:pt idx="2">
                  <c:v>23249.5</c:v>
                </c:pt>
                <c:pt idx="3">
                  <c:v>17058.5</c:v>
                </c:pt>
                <c:pt idx="4">
                  <c:v>9657.5</c:v>
                </c:pt>
                <c:pt idx="5">
                  <c:v>5160</c:v>
                </c:pt>
                <c:pt idx="6">
                  <c:v>2749</c:v>
                </c:pt>
                <c:pt idx="7">
                  <c:v>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45E-4017-B6BF-1B5469525B4F}"/>
            </c:ext>
          </c:extLst>
        </c:ser>
        <c:ser>
          <c:idx val="1"/>
          <c:order val="1"/>
          <c:tx>
            <c:strRef>
              <c:f>'[User 3-ATCC Contrived Accuracy and Precision Analysis.xlsx]Set 2 Data'!$AA$10:$AA$17</c:f>
              <c:strCache>
                <c:ptCount val="8"/>
                <c:pt idx="0">
                  <c:v>Rep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ysClr val="windowText" lastClr="00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[User 3-ATCC Contrived Accuracy and Precision Analysis.xlsx]Set 2 Data'!$AM$10:$AM$17</c:f>
              <c:numCache>
                <c:formatCode>General</c:formatCode>
                <c:ptCount val="8"/>
                <c:pt idx="0">
                  <c:v>0.15</c:v>
                </c:pt>
                <c:pt idx="1">
                  <c:v>0.15</c:v>
                </c:pt>
                <c:pt idx="2">
                  <c:v>0.15</c:v>
                </c:pt>
                <c:pt idx="3">
                  <c:v>0.15</c:v>
                </c:pt>
                <c:pt idx="4">
                  <c:v>0.15</c:v>
                </c:pt>
                <c:pt idx="5">
                  <c:v>0.15</c:v>
                </c:pt>
                <c:pt idx="6">
                  <c:v>0.15</c:v>
                </c:pt>
                <c:pt idx="7">
                  <c:v>0.15</c:v>
                </c:pt>
              </c:numCache>
            </c:numRef>
          </c:xVal>
          <c:yVal>
            <c:numRef>
              <c:f>'[User 3-ATCC Contrived Accuracy and Precision Analysis.xlsx]Set 2 Data'!$M$28:$M$35</c:f>
              <c:numCache>
                <c:formatCode>##0</c:formatCode>
                <c:ptCount val="8"/>
                <c:pt idx="0">
                  <c:v>11781</c:v>
                </c:pt>
                <c:pt idx="1">
                  <c:v>13154.5</c:v>
                </c:pt>
                <c:pt idx="2">
                  <c:v>11461.5</c:v>
                </c:pt>
                <c:pt idx="3">
                  <c:v>11684</c:v>
                </c:pt>
                <c:pt idx="4">
                  <c:v>10634.5</c:v>
                </c:pt>
                <c:pt idx="5">
                  <c:v>9939</c:v>
                </c:pt>
                <c:pt idx="6">
                  <c:v>11712.5</c:v>
                </c:pt>
                <c:pt idx="7">
                  <c:v>1129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45E-4017-B6BF-1B5469525B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0437903"/>
        <c:axId val="320430415"/>
      </c:scatterChart>
      <c:valAx>
        <c:axId val="32043790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0430415"/>
        <c:crosses val="autoZero"/>
        <c:crossBetween val="midCat"/>
      </c:valAx>
      <c:valAx>
        <c:axId val="320430415"/>
        <c:scaling>
          <c:orientation val="minMax"/>
        </c:scaling>
        <c:delete val="0"/>
        <c:axPos val="l"/>
        <c:numFmt formatCode="#,##0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043790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S19F</a:t>
            </a:r>
          </a:p>
        </c:rich>
      </c:tx>
      <c:layout>
        <c:manualLayout>
          <c:xMode val="edge"/>
          <c:yMode val="edge"/>
          <c:x val="0.24373367125796433"/>
          <c:y val="0.148525152403983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17281001828499"/>
          <c:y val="0.17198525152403984"/>
          <c:w val="0.66973966150187525"/>
          <c:h val="0.62244407256544398"/>
        </c:manualLayout>
      </c:layout>
      <c:scatterChart>
        <c:scatterStyle val="lineMarker"/>
        <c:varyColors val="0"/>
        <c:ser>
          <c:idx val="0"/>
          <c:order val="0"/>
          <c:tx>
            <c:strRef>
              <c:f>'[User 2 ATCC Contrived Accuracy and Precision Analysis.xlsx]Set 1 Data'!$AA$2:$AA$9</c:f>
              <c:strCache>
                <c:ptCount val="8"/>
                <c:pt idx="0">
                  <c:v>Standar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solidFill>
                <a:sysClr val="windowText" lastClr="00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trendline>
            <c:spPr>
              <a:ln w="19050" cap="rnd">
                <a:solidFill>
                  <a:sysClr val="windowText" lastClr="000000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4.7059665381333507E-2"/>
                  <c:y val="0.15857314287732915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[User 2 ATCC Contrived Accuracy and Precision Analysis.xlsx]Set 1 Data'!$AT$2:$AT$9</c:f>
              <c:numCache>
                <c:formatCode>General</c:formatCode>
                <c:ptCount val="8"/>
                <c:pt idx="0">
                  <c:v>0.8</c:v>
                </c:pt>
                <c:pt idx="1">
                  <c:v>0.64</c:v>
                </c:pt>
                <c:pt idx="2">
                  <c:v>0.48</c:v>
                </c:pt>
                <c:pt idx="3">
                  <c:v>0.32</c:v>
                </c:pt>
                <c:pt idx="4">
                  <c:v>0.16</c:v>
                </c:pt>
                <c:pt idx="5">
                  <c:v>0.08</c:v>
                </c:pt>
                <c:pt idx="6">
                  <c:v>0.04</c:v>
                </c:pt>
                <c:pt idx="7">
                  <c:v>0</c:v>
                </c:pt>
              </c:numCache>
            </c:numRef>
          </c:xVal>
          <c:yVal>
            <c:numRef>
              <c:f>'[User 2 ATCC Contrived Accuracy and Precision Analysis.xlsx]Set 1 Data'!$T$20:$T$27</c:f>
              <c:numCache>
                <c:formatCode>##0</c:formatCode>
                <c:ptCount val="8"/>
                <c:pt idx="0">
                  <c:v>24089.5</c:v>
                </c:pt>
                <c:pt idx="1">
                  <c:v>22259.5</c:v>
                </c:pt>
                <c:pt idx="2">
                  <c:v>14338</c:v>
                </c:pt>
                <c:pt idx="3">
                  <c:v>8527</c:v>
                </c:pt>
                <c:pt idx="4">
                  <c:v>4980</c:v>
                </c:pt>
                <c:pt idx="5">
                  <c:v>2878</c:v>
                </c:pt>
                <c:pt idx="6">
                  <c:v>1763</c:v>
                </c:pt>
                <c:pt idx="7">
                  <c:v>1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DCD-404E-AE74-F3ED01FF39AD}"/>
            </c:ext>
          </c:extLst>
        </c:ser>
        <c:ser>
          <c:idx val="1"/>
          <c:order val="1"/>
          <c:tx>
            <c:strRef>
              <c:f>'[User 2 ATCC Contrived Accuracy and Precision Analysis.xlsx]Set 1 Data'!$AA$10:$AA$17</c:f>
              <c:strCache>
                <c:ptCount val="8"/>
                <c:pt idx="0">
                  <c:v>Rep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ysClr val="windowText" lastClr="00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[User 2 ATCC Contrived Accuracy and Precision Analysis.xlsx]Set 1 Data'!$AT$10:$AT$17</c:f>
              <c:numCache>
                <c:formatCode>General</c:formatCode>
                <c:ptCount val="8"/>
                <c:pt idx="0">
                  <c:v>0.2</c:v>
                </c:pt>
                <c:pt idx="1">
                  <c:v>0.2</c:v>
                </c:pt>
                <c:pt idx="2">
                  <c:v>0.2</c:v>
                </c:pt>
                <c:pt idx="3">
                  <c:v>0.2</c:v>
                </c:pt>
                <c:pt idx="4">
                  <c:v>0.2</c:v>
                </c:pt>
                <c:pt idx="5">
                  <c:v>0.2</c:v>
                </c:pt>
                <c:pt idx="6">
                  <c:v>0.2</c:v>
                </c:pt>
                <c:pt idx="7">
                  <c:v>0.2</c:v>
                </c:pt>
              </c:numCache>
            </c:numRef>
          </c:xVal>
          <c:yVal>
            <c:numRef>
              <c:f>'[User 2 ATCC Contrived Accuracy and Precision Analysis.xlsx]Set 1 Data'!$T$28:$T$35</c:f>
              <c:numCache>
                <c:formatCode>##0</c:formatCode>
                <c:ptCount val="8"/>
                <c:pt idx="0">
                  <c:v>6625</c:v>
                </c:pt>
                <c:pt idx="1">
                  <c:v>6207.5</c:v>
                </c:pt>
                <c:pt idx="2">
                  <c:v>5436.5</c:v>
                </c:pt>
                <c:pt idx="3">
                  <c:v>5622</c:v>
                </c:pt>
                <c:pt idx="4">
                  <c:v>7495</c:v>
                </c:pt>
                <c:pt idx="5">
                  <c:v>7201.5</c:v>
                </c:pt>
                <c:pt idx="6">
                  <c:v>6622.5</c:v>
                </c:pt>
                <c:pt idx="7">
                  <c:v>49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DCD-404E-AE74-F3ED01FF39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0437903"/>
        <c:axId val="320430415"/>
      </c:scatterChart>
      <c:valAx>
        <c:axId val="32043790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0430415"/>
        <c:crosses val="autoZero"/>
        <c:crossBetween val="midCat"/>
      </c:valAx>
      <c:valAx>
        <c:axId val="320430415"/>
        <c:scaling>
          <c:orientation val="minMax"/>
        </c:scaling>
        <c:delete val="0"/>
        <c:axPos val="l"/>
        <c:numFmt formatCode="#,##0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043790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3C47A-4D61-49A9-851F-A5981CEE6842}" type="datetimeFigureOut">
              <a:rPr lang="en-US" smtClean="0"/>
              <a:t>11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11484-2F4F-40BB-B68E-6AAACF1DF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033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3C47A-4D61-49A9-851F-A5981CEE6842}" type="datetimeFigureOut">
              <a:rPr lang="en-US" smtClean="0"/>
              <a:t>11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11484-2F4F-40BB-B68E-6AAACF1DF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715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3C47A-4D61-49A9-851F-A5981CEE6842}" type="datetimeFigureOut">
              <a:rPr lang="en-US" smtClean="0"/>
              <a:t>11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11484-2F4F-40BB-B68E-6AAACF1DF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431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3C47A-4D61-49A9-851F-A5981CEE6842}" type="datetimeFigureOut">
              <a:rPr lang="en-US" smtClean="0"/>
              <a:t>11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11484-2F4F-40BB-B68E-6AAACF1DF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850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3C47A-4D61-49A9-851F-A5981CEE6842}" type="datetimeFigureOut">
              <a:rPr lang="en-US" smtClean="0"/>
              <a:t>11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11484-2F4F-40BB-B68E-6AAACF1DF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753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3C47A-4D61-49A9-851F-A5981CEE6842}" type="datetimeFigureOut">
              <a:rPr lang="en-US" smtClean="0"/>
              <a:t>11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11484-2F4F-40BB-B68E-6AAACF1DF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077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3C47A-4D61-49A9-851F-A5981CEE6842}" type="datetimeFigureOut">
              <a:rPr lang="en-US" smtClean="0"/>
              <a:t>11/1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11484-2F4F-40BB-B68E-6AAACF1DF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747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3C47A-4D61-49A9-851F-A5981CEE6842}" type="datetimeFigureOut">
              <a:rPr lang="en-US" smtClean="0"/>
              <a:t>11/1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11484-2F4F-40BB-B68E-6AAACF1DF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212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3C47A-4D61-49A9-851F-A5981CEE6842}" type="datetimeFigureOut">
              <a:rPr lang="en-US" smtClean="0"/>
              <a:t>11/1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11484-2F4F-40BB-B68E-6AAACF1DF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615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3C47A-4D61-49A9-851F-A5981CEE6842}" type="datetimeFigureOut">
              <a:rPr lang="en-US" smtClean="0"/>
              <a:t>11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11484-2F4F-40BB-B68E-6AAACF1DF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849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3C47A-4D61-49A9-851F-A5981CEE6842}" type="datetimeFigureOut">
              <a:rPr lang="en-US" smtClean="0"/>
              <a:t>11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11484-2F4F-40BB-B68E-6AAACF1DF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3563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B3C47A-4D61-49A9-851F-A5981CEE6842}" type="datetimeFigureOut">
              <a:rPr lang="en-US" smtClean="0"/>
              <a:t>11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C11484-2F4F-40BB-B68E-6AAACF1DF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349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EA999728-B870-B65A-9967-A8434D1A661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2667693"/>
              </p:ext>
            </p:extLst>
          </p:nvPr>
        </p:nvGraphicFramePr>
        <p:xfrm>
          <a:off x="530485" y="1214607"/>
          <a:ext cx="5915016" cy="4469100"/>
        </p:xfrm>
        <a:graphic>
          <a:graphicData uri="http://schemas.openxmlformats.org/drawingml/2006/table">
            <a:tbl>
              <a:tblPr/>
              <a:tblGrid>
                <a:gridCol w="261336">
                  <a:extLst>
                    <a:ext uri="{9D8B030D-6E8A-4147-A177-3AD203B41FA5}">
                      <a16:colId xmlns:a16="http://schemas.microsoft.com/office/drawing/2014/main" val="1538358781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319506912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664944411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4164757348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2839641685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1903117156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4287446494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4030517480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1584132796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3719455867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2505971518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824162024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4280618306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2281054922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595139354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2028448327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2493485801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3835692272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2172079213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1859653679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1706748562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2836220164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3981069865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2564781773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1320177226"/>
                    </a:ext>
                  </a:extLst>
                </a:gridCol>
              </a:tblGrid>
              <a:tr h="257708">
                <a:tc gridSpan="25"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pplemental Table S1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: Reactivity of conjugates using 23-Mix Primary Detection Label. Signal to blank ratios (S/Bl) generated on the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xArray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23-valent Pneumococcal Assay for monovalent Pfizer- and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iologics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-provided conjugates at 2 µg/mL using the 23-Mix Primary Detection Label. Columns represent each serotype-specific capture antibody, and rows represent each conjugate tested. Text in bold green shows S/Bl&gt;3 generated for the matched conjugate and capture antibody. Text in bold red shows S/Bl&lt;3 generated for the matched conjugate and capture antibody indicating low reactivity. 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ext in bold black shows S/Bl&gt;3 generated on off-target capture antibody indicating cross-reactivity.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03639609"/>
                  </a:ext>
                </a:extLst>
              </a:tr>
              <a:tr h="77313">
                <a:tc gridSpan="25"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otype-Specific </a:t>
                      </a:r>
                      <a:r>
                        <a:rPr lang="en-US" sz="800" b="1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croarry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apture Antibody</a:t>
                      </a:r>
                    </a:p>
                  </a:txBody>
                  <a:tcPr marL="3682" marR="3682" marT="368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66500899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5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6A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6B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7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9N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9V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0A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2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5B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7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8C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9A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9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2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3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33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2463745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5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8997857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2.6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0547833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6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8611459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7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2688860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9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6918087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9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0149852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5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1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6084860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2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0255900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6A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8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0698417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7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8041357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6B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8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8805239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8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8286685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7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9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291787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3.6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0389885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9V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4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678499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0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685781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1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1991650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4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4548737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8C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118163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3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3147280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9A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9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365897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6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0364022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9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2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7978092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6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458542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2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0.5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1337929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3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5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0006128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3.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915613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378462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EA999728-B870-B65A-9967-A8434D1A661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5837311"/>
              </p:ext>
            </p:extLst>
          </p:nvPr>
        </p:nvGraphicFramePr>
        <p:xfrm>
          <a:off x="530485" y="1214607"/>
          <a:ext cx="5915016" cy="4489701"/>
        </p:xfrm>
        <a:graphic>
          <a:graphicData uri="http://schemas.openxmlformats.org/drawingml/2006/table">
            <a:tbl>
              <a:tblPr/>
              <a:tblGrid>
                <a:gridCol w="261336">
                  <a:extLst>
                    <a:ext uri="{9D8B030D-6E8A-4147-A177-3AD203B41FA5}">
                      <a16:colId xmlns:a16="http://schemas.microsoft.com/office/drawing/2014/main" val="1538358781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319506912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664944411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4164757348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2839641685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1903117156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4287446494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4030517480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1584132796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3719455867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2505971518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824162024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4280618306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2281054922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595139354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2028448327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2493485801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3835692272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2172079213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1859653679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1706748562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2836220164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3981069865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2564781773"/>
                    </a:ext>
                  </a:extLst>
                </a:gridCol>
                <a:gridCol w="235570">
                  <a:extLst>
                    <a:ext uri="{9D8B030D-6E8A-4147-A177-3AD203B41FA5}">
                      <a16:colId xmlns:a16="http://schemas.microsoft.com/office/drawing/2014/main" val="1320177226"/>
                    </a:ext>
                  </a:extLst>
                </a:gridCol>
              </a:tblGrid>
              <a:tr h="257708">
                <a:tc gridSpan="25"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pplemental Table S2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: 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eactivity of conjugates using anti-CRM197 Primary Detection Label. Signal to blank ratios (S/Bl) generated on the </a:t>
                      </a:r>
                      <a:r>
                        <a:rPr lang="en-US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axArray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23-valent Pneumococcal Assay for monovalent Pfizer- and </a:t>
                      </a:r>
                      <a:r>
                        <a:rPr lang="en-US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uBiologics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(</a:t>
                      </a:r>
                      <a:r>
                        <a:rPr lang="en-US" sz="9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uB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-provided conjugates at 2 µg/mL labeled with anti-CRM</a:t>
                      </a:r>
                      <a:r>
                        <a:rPr lang="en-US" sz="900" baseline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97</a:t>
                      </a:r>
                      <a:r>
                        <a:rPr lang="en-US" sz="900" baseline="-25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imary Detection Label. Columns represent each serotype-specific capture antibody, and rows represent each conjugate tested. Text in bold green shows S/Bl&gt;3 generated for the matched conjugate and capture antibody. Text in bold black shows S/Bl&gt;3 generated on off-target capture antibody indicating cross-reactivity.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03639609"/>
                  </a:ext>
                </a:extLst>
              </a:tr>
              <a:tr h="77313">
                <a:tc gridSpan="25"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otype-Specific </a:t>
                      </a:r>
                      <a:r>
                        <a:rPr lang="en-US" sz="800" b="1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croarry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apture Antibody</a:t>
                      </a:r>
                    </a:p>
                  </a:txBody>
                  <a:tcPr marL="3682" marR="3682" marT="368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66500899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5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6A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6B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7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8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9N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9V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0A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2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5B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7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8C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9A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9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0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2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3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33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2463745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2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8997857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5.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0547833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3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3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8611459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1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2688860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8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6918087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2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0149852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5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3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6084860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3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0255900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6A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2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0698417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1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8041357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6B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2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8805239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6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8286685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7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0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291787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8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0389885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9V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7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678499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5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685781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4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7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1991650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5.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4548737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8C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3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118163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8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3147280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9A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2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365897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7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0364022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9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9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7978092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5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458542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2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6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1337929"/>
                  </a:ext>
                </a:extLst>
              </a:tr>
              <a:tr h="736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3F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6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0006128"/>
                  </a:ext>
                </a:extLst>
              </a:tr>
              <a:tr h="7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8.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915613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790895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01F00954-E06B-39DE-3631-7A2DD178E8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8824250"/>
              </p:ext>
            </p:extLst>
          </p:nvPr>
        </p:nvGraphicFramePr>
        <p:xfrm>
          <a:off x="471488" y="880999"/>
          <a:ext cx="5915024" cy="4474792"/>
        </p:xfrm>
        <a:graphic>
          <a:graphicData uri="http://schemas.openxmlformats.org/drawingml/2006/table">
            <a:tbl>
              <a:tblPr/>
              <a:tblGrid>
                <a:gridCol w="446241">
                  <a:extLst>
                    <a:ext uri="{9D8B030D-6E8A-4147-A177-3AD203B41FA5}">
                      <a16:colId xmlns:a16="http://schemas.microsoft.com/office/drawing/2014/main" val="2667971018"/>
                    </a:ext>
                  </a:extLst>
                </a:gridCol>
                <a:gridCol w="706549">
                  <a:extLst>
                    <a:ext uri="{9D8B030D-6E8A-4147-A177-3AD203B41FA5}">
                      <a16:colId xmlns:a16="http://schemas.microsoft.com/office/drawing/2014/main" val="3522914359"/>
                    </a:ext>
                  </a:extLst>
                </a:gridCol>
                <a:gridCol w="711197">
                  <a:extLst>
                    <a:ext uri="{9D8B030D-6E8A-4147-A177-3AD203B41FA5}">
                      <a16:colId xmlns:a16="http://schemas.microsoft.com/office/drawing/2014/main" val="624807787"/>
                    </a:ext>
                  </a:extLst>
                </a:gridCol>
                <a:gridCol w="878538">
                  <a:extLst>
                    <a:ext uri="{9D8B030D-6E8A-4147-A177-3AD203B41FA5}">
                      <a16:colId xmlns:a16="http://schemas.microsoft.com/office/drawing/2014/main" val="1301286074"/>
                    </a:ext>
                  </a:extLst>
                </a:gridCol>
                <a:gridCol w="739088">
                  <a:extLst>
                    <a:ext uri="{9D8B030D-6E8A-4147-A177-3AD203B41FA5}">
                      <a16:colId xmlns:a16="http://schemas.microsoft.com/office/drawing/2014/main" val="49714025"/>
                    </a:ext>
                  </a:extLst>
                </a:gridCol>
                <a:gridCol w="878538">
                  <a:extLst>
                    <a:ext uri="{9D8B030D-6E8A-4147-A177-3AD203B41FA5}">
                      <a16:colId xmlns:a16="http://schemas.microsoft.com/office/drawing/2014/main" val="941295096"/>
                    </a:ext>
                  </a:extLst>
                </a:gridCol>
                <a:gridCol w="676335">
                  <a:extLst>
                    <a:ext uri="{9D8B030D-6E8A-4147-A177-3AD203B41FA5}">
                      <a16:colId xmlns:a16="http://schemas.microsoft.com/office/drawing/2014/main" val="3619747886"/>
                    </a:ext>
                  </a:extLst>
                </a:gridCol>
                <a:gridCol w="878538">
                  <a:extLst>
                    <a:ext uri="{9D8B030D-6E8A-4147-A177-3AD203B41FA5}">
                      <a16:colId xmlns:a16="http://schemas.microsoft.com/office/drawing/2014/main" val="1620445326"/>
                    </a:ext>
                  </a:extLst>
                </a:gridCol>
              </a:tblGrid>
              <a:tr h="139863">
                <a:tc gridSpan="8"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pplemental Table S3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: Analytical sensitivity and working range for 13-valent Pfizer conjugates and 14-valent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iologics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 conjugates with both 23-Mix and anti-CRM197 Primary Detection Labels. “NA”: not applicable due to low signal on S18C capture. </a:t>
                      </a:r>
                    </a:p>
                  </a:txBody>
                  <a:tcPr marL="7285" marR="7285" marT="72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60260996"/>
                  </a:ext>
                </a:extLst>
              </a:tr>
              <a:tr h="1398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otype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pplier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prox. LLOQ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ng/mL)</a:t>
                      </a:r>
                    </a:p>
                  </a:txBody>
                  <a:tcPr marL="7285" marR="7285" marT="72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prox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ULOQ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</a:t>
                      </a:r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μ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/mL)</a:t>
                      </a:r>
                    </a:p>
                  </a:txBody>
                  <a:tcPr marL="7285" marR="7285" marT="72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orking Range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x-fold)</a:t>
                      </a:r>
                    </a:p>
                  </a:txBody>
                  <a:tcPr marL="7285" marR="7285" marT="72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28180110"/>
                  </a:ext>
                </a:extLst>
              </a:tr>
              <a:tr h="13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-Mix Label</a:t>
                      </a:r>
                    </a:p>
                  </a:txBody>
                  <a:tcPr marL="7285" marR="7285" marT="72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-CRM197 Label</a:t>
                      </a:r>
                    </a:p>
                  </a:txBody>
                  <a:tcPr marL="7285" marR="7285" marT="728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-Mix Label</a:t>
                      </a:r>
                    </a:p>
                  </a:txBody>
                  <a:tcPr marL="7285" marR="7285" marT="72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-CRM197 Label</a:t>
                      </a:r>
                    </a:p>
                  </a:txBody>
                  <a:tcPr marL="7285" marR="7285" marT="728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-Mix Label</a:t>
                      </a:r>
                    </a:p>
                  </a:txBody>
                  <a:tcPr marL="7285" marR="7285" marT="72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-CRM197 Label</a:t>
                      </a:r>
                    </a:p>
                  </a:txBody>
                  <a:tcPr marL="7285" marR="7285" marT="72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0016128"/>
                  </a:ext>
                </a:extLst>
              </a:tr>
              <a:tr h="1398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6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1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9182426"/>
                  </a:ext>
                </a:extLst>
              </a:tr>
              <a:tr h="13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5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6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0969151"/>
                  </a:ext>
                </a:extLst>
              </a:tr>
              <a:tr h="1398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7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1737835"/>
                  </a:ext>
                </a:extLst>
              </a:tr>
              <a:tr h="13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4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8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9132517"/>
                  </a:ext>
                </a:extLst>
              </a:tr>
              <a:tr h="1398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4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8318075"/>
                  </a:ext>
                </a:extLst>
              </a:tr>
              <a:tr h="13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5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7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2551593"/>
                  </a:ext>
                </a:extLst>
              </a:tr>
              <a:tr h="1398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6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8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2875139"/>
                  </a:ext>
                </a:extLst>
              </a:tr>
              <a:tr h="13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.0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.9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2687581"/>
                  </a:ext>
                </a:extLst>
              </a:tr>
              <a:tr h="1398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A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3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4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642693"/>
                  </a:ext>
                </a:extLst>
              </a:tr>
              <a:tr h="13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.5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7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8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4261339"/>
                  </a:ext>
                </a:extLst>
              </a:tr>
              <a:tr h="1398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B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3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6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0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8521938"/>
                  </a:ext>
                </a:extLst>
              </a:tr>
              <a:tr h="13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.0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8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8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4302641"/>
                  </a:ext>
                </a:extLst>
              </a:tr>
              <a:tr h="1398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F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4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2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7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7911571"/>
                  </a:ext>
                </a:extLst>
              </a:tr>
              <a:tr h="13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2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.7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0483765"/>
                  </a:ext>
                </a:extLst>
              </a:tr>
              <a:tr h="1398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V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8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9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9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4702381"/>
                  </a:ext>
                </a:extLst>
              </a:tr>
              <a:tr h="13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0.7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3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1394335"/>
                  </a:ext>
                </a:extLst>
              </a:tr>
              <a:tr h="1398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.8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5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8509566"/>
                  </a:ext>
                </a:extLst>
              </a:tr>
              <a:tr h="13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2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4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9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0877643"/>
                  </a:ext>
                </a:extLst>
              </a:tr>
              <a:tr h="1398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C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NA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9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N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9726842"/>
                  </a:ext>
                </a:extLst>
              </a:tr>
              <a:tr h="13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0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8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0515599"/>
                  </a:ext>
                </a:extLst>
              </a:tr>
              <a:tr h="1398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A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9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8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0781835"/>
                  </a:ext>
                </a:extLst>
              </a:tr>
              <a:tr h="13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.0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5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4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5737321"/>
                  </a:ext>
                </a:extLst>
              </a:tr>
              <a:tr h="1398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F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6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3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4332479"/>
                  </a:ext>
                </a:extLst>
              </a:tr>
              <a:tr h="13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5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7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5941134"/>
                  </a:ext>
                </a:extLst>
              </a:tr>
              <a:tr h="13986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F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1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0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7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1729607"/>
                  </a:ext>
                </a:extLst>
              </a:tr>
              <a:tr h="1398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F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izer</a:t>
                      </a: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2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1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7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5824070"/>
                  </a:ext>
                </a:extLst>
              </a:tr>
              <a:tr h="13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2" marR="3682" marT="368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8.1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1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7285" marR="7285" marT="72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7</a:t>
                      </a:r>
                    </a:p>
                  </a:txBody>
                  <a:tcPr marL="7285" marR="7285" marT="72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841863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435516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4B7766D5-5BEA-1E99-2962-70D87BC8F50E}"/>
              </a:ext>
            </a:extLst>
          </p:cNvPr>
          <p:cNvCxnSpPr/>
          <p:nvPr/>
        </p:nvCxnSpPr>
        <p:spPr>
          <a:xfrm>
            <a:off x="1038225" y="4516291"/>
            <a:ext cx="4724400" cy="9525"/>
          </a:xfrm>
          <a:prstGeom prst="line">
            <a:avLst/>
          </a:prstGeom>
          <a:ln w="19050">
            <a:noFill/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C9A41C65-C6F9-575D-0C90-A736A7F171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20640441"/>
              </p:ext>
            </p:extLst>
          </p:nvPr>
        </p:nvGraphicFramePr>
        <p:xfrm>
          <a:off x="1362793" y="1150379"/>
          <a:ext cx="4075900" cy="2911099"/>
        </p:xfrm>
        <a:graphic>
          <a:graphicData uri="http://schemas.openxmlformats.org/drawingml/2006/table">
            <a:tbl>
              <a:tblPr/>
              <a:tblGrid>
                <a:gridCol w="536788">
                  <a:extLst>
                    <a:ext uri="{9D8B030D-6E8A-4147-A177-3AD203B41FA5}">
                      <a16:colId xmlns:a16="http://schemas.microsoft.com/office/drawing/2014/main" val="492125781"/>
                    </a:ext>
                  </a:extLst>
                </a:gridCol>
                <a:gridCol w="612426">
                  <a:extLst>
                    <a:ext uri="{9D8B030D-6E8A-4147-A177-3AD203B41FA5}">
                      <a16:colId xmlns:a16="http://schemas.microsoft.com/office/drawing/2014/main" val="3919992332"/>
                    </a:ext>
                  </a:extLst>
                </a:gridCol>
                <a:gridCol w="653431">
                  <a:extLst>
                    <a:ext uri="{9D8B030D-6E8A-4147-A177-3AD203B41FA5}">
                      <a16:colId xmlns:a16="http://schemas.microsoft.com/office/drawing/2014/main" val="3240804134"/>
                    </a:ext>
                  </a:extLst>
                </a:gridCol>
                <a:gridCol w="745092">
                  <a:extLst>
                    <a:ext uri="{9D8B030D-6E8A-4147-A177-3AD203B41FA5}">
                      <a16:colId xmlns:a16="http://schemas.microsoft.com/office/drawing/2014/main" val="370661268"/>
                    </a:ext>
                  </a:extLst>
                </a:gridCol>
                <a:gridCol w="715655">
                  <a:extLst>
                    <a:ext uri="{9D8B030D-6E8A-4147-A177-3AD203B41FA5}">
                      <a16:colId xmlns:a16="http://schemas.microsoft.com/office/drawing/2014/main" val="3391324178"/>
                    </a:ext>
                  </a:extLst>
                </a:gridCol>
                <a:gridCol w="812508">
                  <a:extLst>
                    <a:ext uri="{9D8B030D-6E8A-4147-A177-3AD203B41FA5}">
                      <a16:colId xmlns:a16="http://schemas.microsoft.com/office/drawing/2014/main" val="447964464"/>
                    </a:ext>
                  </a:extLst>
                </a:gridCol>
              </a:tblGrid>
              <a:tr h="294056">
                <a:tc gridSpan="6"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pplemental Table S4: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uracy and precision for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iologics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15-valent drug product with and without sodium citrate desorption using 23-Mix Primary Detection Label. Text in red indicates values not within 80-120% recovery and &lt; 20% RSD.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61131736"/>
                  </a:ext>
                </a:extLst>
              </a:tr>
              <a:tr h="10299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otype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pected Conc. (</a:t>
                      </a:r>
                      <a:r>
                        <a:rPr lang="el-GR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μ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/m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Desorp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orbed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84401648"/>
                  </a:ext>
                </a:extLst>
              </a:tr>
              <a:tr h="25552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uracy </a:t>
                      </a:r>
                      <a:b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% Recovery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cision </a:t>
                      </a:r>
                      <a:b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%RSD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uracy </a:t>
                      </a:r>
                      <a:b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% Recovery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cision </a:t>
                      </a:r>
                      <a:b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%RSD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8789850"/>
                  </a:ext>
                </a:extLst>
              </a:tr>
              <a:tr h="1029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8%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%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7821214"/>
                  </a:ext>
                </a:extLst>
              </a:tr>
              <a:tr h="1029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6458434"/>
                  </a:ext>
                </a:extLst>
              </a:tr>
              <a:tr h="1029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7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24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%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%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2196172"/>
                  </a:ext>
                </a:extLst>
              </a:tr>
              <a:tr h="1029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1142703"/>
                  </a:ext>
                </a:extLst>
              </a:tr>
              <a:tr h="1029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6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5366264"/>
                  </a:ext>
                </a:extLst>
              </a:tr>
              <a:tr h="1029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6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1466076"/>
                  </a:ext>
                </a:extLst>
              </a:tr>
              <a:tr h="1029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7F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7305357"/>
                  </a:ext>
                </a:extLst>
              </a:tr>
              <a:tr h="1029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9V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7955416"/>
                  </a:ext>
                </a:extLst>
              </a:tr>
              <a:tr h="1029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3604718"/>
                  </a:ext>
                </a:extLst>
              </a:tr>
              <a:tr h="1029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8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2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6876024"/>
                  </a:ext>
                </a:extLst>
              </a:tr>
              <a:tr h="1029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9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7631587"/>
                  </a:ext>
                </a:extLst>
              </a:tr>
              <a:tr h="1029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9F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27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1614591"/>
                  </a:ext>
                </a:extLst>
              </a:tr>
              <a:tr h="1029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2F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144098"/>
                  </a:ext>
                </a:extLst>
              </a:tr>
              <a:tr h="1029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3F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65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4853492"/>
                  </a:ext>
                </a:extLst>
              </a:tr>
              <a:tr h="102994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eral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±23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±1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±10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±4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3137511"/>
                  </a:ext>
                </a:extLst>
              </a:tr>
              <a:tr h="102994">
                <a:tc gridSpan="6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: Data is from 400ms exposure, Std 1 signal saturated at 700ms.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358346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989289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58ED7440-DAD8-9C07-B59D-F1B066DBDC82}"/>
              </a:ext>
            </a:extLst>
          </p:cNvPr>
          <p:cNvGrpSpPr/>
          <p:nvPr/>
        </p:nvGrpSpPr>
        <p:grpSpPr>
          <a:xfrm>
            <a:off x="398721" y="520997"/>
            <a:ext cx="6133204" cy="2175140"/>
            <a:chOff x="398721" y="520997"/>
            <a:chExt cx="6133204" cy="2175140"/>
          </a:xfrm>
        </p:grpSpPr>
        <p:graphicFrame>
          <p:nvGraphicFramePr>
            <p:cNvPr id="2" name="Chart 1">
              <a:extLst>
                <a:ext uri="{FF2B5EF4-FFF2-40B4-BE49-F238E27FC236}">
                  <a16:creationId xmlns:a16="http://schemas.microsoft.com/office/drawing/2014/main" id="{5D716A0B-E8F6-4007-93DC-2E2BBD782E4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5271944"/>
                </p:ext>
              </p:extLst>
            </p:nvPr>
          </p:nvGraphicFramePr>
          <p:xfrm>
            <a:off x="398721" y="571889"/>
            <a:ext cx="2397643" cy="212424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4FC318B6-89A7-48C8-834D-1B8F962F6B8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67931660"/>
                </p:ext>
              </p:extLst>
            </p:nvPr>
          </p:nvGraphicFramePr>
          <p:xfrm>
            <a:off x="2441689" y="520997"/>
            <a:ext cx="2353329" cy="211361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8AEE2A52-1949-463D-A732-B1405AD009C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73303409"/>
                </p:ext>
              </p:extLst>
            </p:nvPr>
          </p:nvGraphicFramePr>
          <p:xfrm>
            <a:off x="4241868" y="520997"/>
            <a:ext cx="2290057" cy="21751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519F3A60-A12F-0ED3-31EB-028CA484C703}"/>
              </a:ext>
            </a:extLst>
          </p:cNvPr>
          <p:cNvSpPr txBox="1"/>
          <p:nvPr/>
        </p:nvSpPr>
        <p:spPr>
          <a:xfrm>
            <a:off x="316789" y="2634612"/>
            <a:ext cx="6098176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US" sz="900" b="1" dirty="0">
                <a:ea typeface="Calibri" panose="020F0502020204030204" pitchFamily="34" charset="0"/>
                <a:cs typeface="Times New Roman" panose="02020603050405020304" pitchFamily="18" charset="0"/>
              </a:rPr>
              <a:t>Supplemental </a:t>
            </a:r>
            <a:r>
              <a:rPr lang="en-US" sz="9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Figure S</a:t>
            </a:r>
            <a:r>
              <a:rPr lang="en-US" sz="900" b="1" dirty="0"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9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ea typeface="Calibri" panose="020F0502020204030204" pitchFamily="34" charset="0"/>
                <a:cs typeface="Times New Roman" panose="02020603050405020304" pitchFamily="18" charset="0"/>
              </a:rPr>
              <a:t>Signal response (median signal with background signal subtracted) of samples measured (triangles) and matched standard (squares) for Serotype 5, 10A and 19F in 23-valent Pfizer native sample. Linear fits are dotted lines with the associated correlation efficient indicated.  </a:t>
            </a:r>
            <a:endParaRPr lang="en-US" sz="9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1509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2367BC3C-F65E-4BC3-9F5C-4806CC0E218A}"/>
              </a:ext>
            </a:extLst>
          </p:cNvPr>
          <p:cNvSpPr txBox="1"/>
          <p:nvPr/>
        </p:nvSpPr>
        <p:spPr>
          <a:xfrm>
            <a:off x="1722578" y="4064169"/>
            <a:ext cx="338528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US" sz="9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l Figure S</a:t>
            </a:r>
            <a:r>
              <a:rPr lang="en-US" sz="900" b="1" dirty="0"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9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ea typeface="Calibri" panose="020F0502020204030204" pitchFamily="34" charset="0"/>
                <a:cs typeface="Times New Roman" panose="02020603050405020304" pitchFamily="18" charset="0"/>
              </a:rPr>
              <a:t>Representative fluorescence microarray images of samples under quantification before desorption (left) and post-desorption (right) showing improved microarray spot morphologies.</a:t>
            </a:r>
            <a:endParaRPr lang="en-US" sz="9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8F532D02-AB08-7339-08EE-2551FC4EEC92}"/>
              </a:ext>
            </a:extLst>
          </p:cNvPr>
          <p:cNvGrpSpPr/>
          <p:nvPr/>
        </p:nvGrpSpPr>
        <p:grpSpPr>
          <a:xfrm>
            <a:off x="1790651" y="1393333"/>
            <a:ext cx="3276698" cy="2533337"/>
            <a:chOff x="885902" y="3600661"/>
            <a:chExt cx="3276698" cy="2533337"/>
          </a:xfrm>
        </p:grpSpPr>
        <p:pic>
          <p:nvPicPr>
            <p:cNvPr id="9" name="Picture 8" descr="Background pattern&#10;&#10;Description automatically generated">
              <a:extLst>
                <a:ext uri="{FF2B5EF4-FFF2-40B4-BE49-F238E27FC236}">
                  <a16:creationId xmlns:a16="http://schemas.microsoft.com/office/drawing/2014/main" id="{CC077419-C3E6-17CD-BE34-54AB57EFE83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48332" y="3802278"/>
              <a:ext cx="1614268" cy="2331720"/>
            </a:xfrm>
            <a:prstGeom prst="rect">
              <a:avLst/>
            </a:prstGeom>
          </p:spPr>
        </p:pic>
        <p:pic>
          <p:nvPicPr>
            <p:cNvPr id="6" name="Picture 5" descr="Background pattern&#10;&#10;Description automatically generated with medium confidence">
              <a:extLst>
                <a:ext uri="{FF2B5EF4-FFF2-40B4-BE49-F238E27FC236}">
                  <a16:creationId xmlns:a16="http://schemas.microsoft.com/office/drawing/2014/main" id="{B2DBC6A9-378B-EA50-DA54-D440867E1FD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5902" y="3802278"/>
              <a:ext cx="1614268" cy="2331720"/>
            </a:xfrm>
            <a:prstGeom prst="rect">
              <a:avLst/>
            </a:prstGeom>
          </p:spPr>
        </p:pic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C519F766-7237-C67C-5469-E7C8D51AE4B2}"/>
                </a:ext>
              </a:extLst>
            </p:cNvPr>
            <p:cNvGrpSpPr/>
            <p:nvPr/>
          </p:nvGrpSpPr>
          <p:grpSpPr>
            <a:xfrm>
              <a:off x="1185462" y="3600661"/>
              <a:ext cx="1262435" cy="2353803"/>
              <a:chOff x="2716983" y="3835124"/>
              <a:chExt cx="1262435" cy="2353803"/>
            </a:xfrm>
          </p:grpSpPr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70B642A2-9A7B-2BB1-A14B-5ABFC2988E8B}"/>
                  </a:ext>
                </a:extLst>
              </p:cNvPr>
              <p:cNvSpPr txBox="1"/>
              <p:nvPr/>
            </p:nvSpPr>
            <p:spPr>
              <a:xfrm>
                <a:off x="2716983" y="3835124"/>
                <a:ext cx="101830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/>
                  <a:t>No Desorption</a:t>
                </a:r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8E095657-536E-E0C6-B84E-27DCAB429201}"/>
                  </a:ext>
                </a:extLst>
              </p:cNvPr>
              <p:cNvSpPr/>
              <p:nvPr/>
            </p:nvSpPr>
            <p:spPr>
              <a:xfrm>
                <a:off x="3333135" y="5675971"/>
                <a:ext cx="646283" cy="512956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1D7FE61E-6AE8-FD0C-296E-C0BE93580A04}"/>
                </a:ext>
              </a:extLst>
            </p:cNvPr>
            <p:cNvGrpSpPr/>
            <p:nvPr/>
          </p:nvGrpSpPr>
          <p:grpSpPr>
            <a:xfrm>
              <a:off x="2807849" y="3601554"/>
              <a:ext cx="1308728" cy="2364060"/>
              <a:chOff x="4581151" y="4081345"/>
              <a:chExt cx="1308728" cy="2364060"/>
            </a:xfrm>
          </p:grpSpPr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BC8A28CB-B710-E44A-1C0C-A5310DE9C391}"/>
                  </a:ext>
                </a:extLst>
              </p:cNvPr>
              <p:cNvSpPr txBox="1"/>
              <p:nvPr/>
            </p:nvSpPr>
            <p:spPr>
              <a:xfrm>
                <a:off x="4581151" y="4081345"/>
                <a:ext cx="101830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/>
                  <a:t>Desorbed</a:t>
                </a:r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1677EE15-009E-F960-69C9-39906FD3CC4D}"/>
                  </a:ext>
                </a:extLst>
              </p:cNvPr>
              <p:cNvSpPr/>
              <p:nvPr/>
            </p:nvSpPr>
            <p:spPr>
              <a:xfrm>
                <a:off x="5243596" y="5932449"/>
                <a:ext cx="646283" cy="512956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0681747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1</TotalTime>
  <Words>2215</Words>
  <Application>Microsoft Office PowerPoint</Application>
  <PresentationFormat>Letter Paper (8.5x11 in)</PresentationFormat>
  <Paragraphs>170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ca Dawson</dc:creator>
  <cp:lastModifiedBy>MDPI</cp:lastModifiedBy>
  <cp:revision>7</cp:revision>
  <dcterms:created xsi:type="dcterms:W3CDTF">2022-04-11T20:38:51Z</dcterms:created>
  <dcterms:modified xsi:type="dcterms:W3CDTF">2022-11-19T07:54:09Z</dcterms:modified>
</cp:coreProperties>
</file>